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80" r:id="rId2"/>
    <p:sldId id="281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0" d="100"/>
          <a:sy n="70" d="100"/>
        </p:scale>
        <p:origin x="138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002B65-5659-0D41-B6EC-C04953EA1B8C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24DA28-3FEE-A647-8B34-4045B99FD9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6541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B549B-EFB4-E549-B2F7-ABD467CA2DE0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ED4BA-13A2-EF40-972E-A0273C2409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3023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B549B-EFB4-E549-B2F7-ABD467CA2DE0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ED4BA-13A2-EF40-972E-A0273C2409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8179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B549B-EFB4-E549-B2F7-ABD467CA2DE0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ED4BA-13A2-EF40-972E-A0273C2409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4627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B549B-EFB4-E549-B2F7-ABD467CA2DE0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ED4BA-13A2-EF40-972E-A0273C2409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5737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B549B-EFB4-E549-B2F7-ABD467CA2DE0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ED4BA-13A2-EF40-972E-A0273C2409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620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B549B-EFB4-E549-B2F7-ABD467CA2DE0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ED4BA-13A2-EF40-972E-A0273C2409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73222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B549B-EFB4-E549-B2F7-ABD467CA2DE0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ED4BA-13A2-EF40-972E-A0273C2409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269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B549B-EFB4-E549-B2F7-ABD467CA2DE0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ED4BA-13A2-EF40-972E-A0273C2409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3650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B549B-EFB4-E549-B2F7-ABD467CA2DE0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ED4BA-13A2-EF40-972E-A0273C2409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748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B549B-EFB4-E549-B2F7-ABD467CA2DE0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ED4BA-13A2-EF40-972E-A0273C2409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7661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B549B-EFB4-E549-B2F7-ABD467CA2DE0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ED4BA-13A2-EF40-972E-A0273C2409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8044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AB549B-EFB4-E549-B2F7-ABD467CA2DE0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AED4BA-13A2-EF40-972E-A0273C2409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0117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4831" y="68267"/>
            <a:ext cx="118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Figure S9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3" name="Picture 2" descr="FigS9_CSS_RC_means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1059" y="437599"/>
            <a:ext cx="6291875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08060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36477" y="109182"/>
            <a:ext cx="8857397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Figure S9. Mean lung resistance after HDM sensitization and challenge in C57BL/6J and C57BL/6J</a:t>
            </a:r>
            <a:r>
              <a:rPr lang="en-US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hr19 A/J Na/J</a:t>
            </a:r>
            <a:r>
              <a:rPr lang="en-US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mice. Data points represent mean resistance recorded during 3 minutes after methacholine nebulization. Thirteen C57BL/6J mice and nine C57BL/6J</a:t>
            </a:r>
            <a:r>
              <a:rPr lang="en-US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hr19 A/J Na/J </a:t>
            </a:r>
            <a:r>
              <a:rPr lang="en-US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ice were </a:t>
            </a:r>
            <a:r>
              <a:rPr lang="en-US" dirty="0" err="1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phenotyped</a:t>
            </a:r>
            <a:r>
              <a:rPr lang="en-US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.</a:t>
            </a:r>
            <a:endParaRPr lang="en-US" dirty="0">
              <a:effectLst/>
              <a:latin typeface="Times New Roman" panose="020206030504050203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24280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17</TotalTime>
  <Words>46</Words>
  <Application>Microsoft Office PowerPoint</Application>
  <PresentationFormat>On-screen Show (4:3)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MS Mincho</vt:lpstr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>UN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ir Kelada</dc:creator>
  <cp:lastModifiedBy>Sarah Wolper</cp:lastModifiedBy>
  <cp:revision>173</cp:revision>
  <dcterms:created xsi:type="dcterms:W3CDTF">2014-04-08T18:55:32Z</dcterms:created>
  <dcterms:modified xsi:type="dcterms:W3CDTF">2016-07-20T19:40:17Z</dcterms:modified>
</cp:coreProperties>
</file>